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56EAF76-8FE0-40D8-98A7-EA670E86F357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48BBC32-34F2-4C9C-831E-643DD0B49A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7881823-04C7-4752-A54C-0E42C252E4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44EDFC7-8D8B-4284-A4C8-CB3271728E1E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09CC38D-E50F-4ACB-908A-65E7AC4D28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4D6FDB6-2026-4A79-8D2F-07C9A228D8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514439E-0711-409F-9A9C-D54B0D35D2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1963CBC-9216-4682-8826-FCDD795C17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9AE017B-C411-445B-8977-6B670BAD57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C0262BA-1786-444C-A1B9-9763AAA53F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3AAAD2D-3810-41D0-995F-D5F93F14EB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8CF1400-75C2-42E7-A315-579C07EF7E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de-DE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de-DE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98D73D35-75FA-4994-BC5E-9D5B8F003D5B}" type="slidenum">
              <a:rPr b="0" lang="de-DE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74680" y="1042920"/>
            <a:ext cx="6310440" cy="4712400"/>
            <a:chOff x="274680" y="1042920"/>
            <a:chExt cx="6310440" cy="4712400"/>
          </a:xfrm>
        </p:grpSpPr>
        <p:sp>
          <p:nvSpPr>
            <p:cNvPr id="42" name=""/>
            <p:cNvSpPr/>
            <p:nvPr/>
          </p:nvSpPr>
          <p:spPr>
            <a:xfrm>
              <a:off x="279360" y="1042920"/>
              <a:ext cx="381636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47 FMS patients: initially intereste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74680" y="2224080"/>
              <a:ext cx="381636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Telephone interview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4" name=""/>
            <p:cNvCxnSpPr/>
            <p:nvPr/>
          </p:nvCxnSpPr>
          <p:spPr>
            <a:xfrm>
              <a:off x="2182320" y="1474560"/>
              <a:ext cx="2520" cy="64836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round/>
            </a:ln>
          </p:spPr>
        </p:cxnSp>
        <p:sp>
          <p:nvSpPr>
            <p:cNvPr id="45" name=""/>
            <p:cNvSpPr/>
            <p:nvPr/>
          </p:nvSpPr>
          <p:spPr>
            <a:xfrm>
              <a:off x="274680" y="3554280"/>
              <a:ext cx="3816360" cy="5202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7/47 eligible; were examined at the Department of Neurology, University of Würzburg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6" name=""/>
            <p:cNvCxnSpPr/>
            <p:nvPr/>
          </p:nvCxnSpPr>
          <p:spPr>
            <a:xfrm>
              <a:off x="2182320" y="2804760"/>
              <a:ext cx="2520" cy="64836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round/>
            </a:ln>
          </p:spPr>
        </p:cxnSp>
        <p:cxnSp>
          <p:nvCxnSpPr>
            <p:cNvPr id="47" name=""/>
            <p:cNvCxnSpPr/>
            <p:nvPr/>
          </p:nvCxnSpPr>
          <p:spPr>
            <a:xfrm>
              <a:off x="2335320" y="3110040"/>
              <a:ext cx="2016720" cy="2160"/>
            </a:xfrm>
            <a:prstGeom prst="bentConnector3">
              <a:avLst>
                <a:gd name="adj1" fmla="val 49991"/>
              </a:avLst>
            </a:prstGeom>
            <a:ln w="9360">
              <a:solidFill>
                <a:srgbClr val="000000"/>
              </a:solidFill>
              <a:round/>
            </a:ln>
          </p:spPr>
        </p:cxnSp>
        <p:sp>
          <p:nvSpPr>
            <p:cNvPr id="48" name=""/>
            <p:cNvSpPr/>
            <p:nvPr/>
          </p:nvSpPr>
          <p:spPr>
            <a:xfrm>
              <a:off x="4451400" y="2701800"/>
              <a:ext cx="2133720" cy="7333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0/47: did not fulfill inclusion criteria; fulfilled exclusion criteria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74680" y="5448240"/>
              <a:ext cx="381636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5/47 include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0" name=""/>
            <p:cNvCxnSpPr/>
            <p:nvPr/>
          </p:nvCxnSpPr>
          <p:spPr>
            <a:xfrm>
              <a:off x="2182320" y="4698720"/>
              <a:ext cx="2520" cy="649800"/>
            </a:xfrm>
            <a:prstGeom prst="bentConnector3">
              <a:avLst>
                <a:gd name="adj1" fmla="val 50000"/>
              </a:avLst>
            </a:prstGeom>
            <a:ln w="9360">
              <a:solidFill>
                <a:srgbClr val="000000"/>
              </a:solidFill>
              <a:round/>
            </a:ln>
          </p:spPr>
        </p:cxnSp>
        <p:cxnSp>
          <p:nvCxnSpPr>
            <p:cNvPr id="51" name=""/>
            <p:cNvCxnSpPr/>
            <p:nvPr/>
          </p:nvCxnSpPr>
          <p:spPr>
            <a:xfrm>
              <a:off x="2335320" y="5003280"/>
              <a:ext cx="2016720" cy="2520"/>
            </a:xfrm>
            <a:prstGeom prst="bentConnector3">
              <a:avLst>
                <a:gd name="adj1" fmla="val 49991"/>
              </a:avLst>
            </a:prstGeom>
            <a:ln w="9360">
              <a:solidFill>
                <a:srgbClr val="000000"/>
              </a:solidFill>
              <a:round/>
            </a:ln>
          </p:spPr>
        </p:cxnSp>
        <p:sp>
          <p:nvSpPr>
            <p:cNvPr id="52" name=""/>
            <p:cNvSpPr/>
            <p:nvPr/>
          </p:nvSpPr>
          <p:spPr>
            <a:xfrm>
              <a:off x="4451400" y="4597560"/>
              <a:ext cx="2133720" cy="7333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/27: did not fulfill inclusion criteria; fulfilled exclusion criteria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" name=""/>
          <p:cNvSpPr/>
          <p:nvPr/>
        </p:nvSpPr>
        <p:spPr>
          <a:xfrm>
            <a:off x="11160" y="8666280"/>
            <a:ext cx="434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2: </a:t>
            </a:r>
            <a:r>
              <a:rPr b="1" lang="de-DE" sz="1800" spc="-1" strike="noStrike">
                <a:solidFill>
                  <a:srgbClr val="000000"/>
                </a:solidFill>
                <a:latin typeface="Times New Roman"/>
                <a:ea typeface="Arial"/>
              </a:rPr>
              <a:t> 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25T21:27:27Z</dcterms:created>
  <dc:creator>N. Üceyler</dc:creator>
  <dc:description/>
  <dc:language>en-US</dc:language>
  <cp:lastModifiedBy>Üçeyler, Nurcan</cp:lastModifiedBy>
  <dcterms:modified xsi:type="dcterms:W3CDTF">2015-08-09T13:48:05Z</dcterms:modified>
  <cp:revision>4</cp:revision>
  <dc:subject/>
  <dc:title>PowerPoint-Präsentation</dc:title>
</cp:coreProperties>
</file>